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day length</c:v>
          </c:tx>
          <c:spPr>
            <a:ln w="15875" cap="rnd">
              <a:solidFill>
                <a:schemeClr val="bg2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graph 2'!$D$3:$D$38</c:f>
              <c:numCache>
                <c:formatCode>d\-mmm</c:formatCode>
                <c:ptCount val="36"/>
                <c:pt idx="0">
                  <c:v>44519</c:v>
                </c:pt>
                <c:pt idx="1">
                  <c:v>44524</c:v>
                </c:pt>
                <c:pt idx="2">
                  <c:v>44529</c:v>
                </c:pt>
                <c:pt idx="3">
                  <c:v>44534</c:v>
                </c:pt>
                <c:pt idx="4">
                  <c:v>44539</c:v>
                </c:pt>
                <c:pt idx="5">
                  <c:v>44544</c:v>
                </c:pt>
                <c:pt idx="6">
                  <c:v>44549</c:v>
                </c:pt>
                <c:pt idx="7">
                  <c:v>44554</c:v>
                </c:pt>
                <c:pt idx="8">
                  <c:v>44559</c:v>
                </c:pt>
                <c:pt idx="9">
                  <c:v>44564</c:v>
                </c:pt>
                <c:pt idx="10">
                  <c:v>44569</c:v>
                </c:pt>
                <c:pt idx="11">
                  <c:v>44574</c:v>
                </c:pt>
                <c:pt idx="12">
                  <c:v>44579</c:v>
                </c:pt>
                <c:pt idx="13">
                  <c:v>44584</c:v>
                </c:pt>
                <c:pt idx="14">
                  <c:v>44589</c:v>
                </c:pt>
                <c:pt idx="15">
                  <c:v>44594</c:v>
                </c:pt>
                <c:pt idx="16">
                  <c:v>44599</c:v>
                </c:pt>
                <c:pt idx="17">
                  <c:v>44604</c:v>
                </c:pt>
                <c:pt idx="18">
                  <c:v>44609</c:v>
                </c:pt>
                <c:pt idx="19">
                  <c:v>44614</c:v>
                </c:pt>
                <c:pt idx="20">
                  <c:v>44619</c:v>
                </c:pt>
                <c:pt idx="21">
                  <c:v>44624</c:v>
                </c:pt>
                <c:pt idx="22">
                  <c:v>44629</c:v>
                </c:pt>
                <c:pt idx="23">
                  <c:v>44634</c:v>
                </c:pt>
                <c:pt idx="24">
                  <c:v>44639</c:v>
                </c:pt>
                <c:pt idx="25">
                  <c:v>44644</c:v>
                </c:pt>
                <c:pt idx="26">
                  <c:v>44649</c:v>
                </c:pt>
                <c:pt idx="27">
                  <c:v>44654</c:v>
                </c:pt>
                <c:pt idx="28">
                  <c:v>44659</c:v>
                </c:pt>
                <c:pt idx="29">
                  <c:v>44664</c:v>
                </c:pt>
                <c:pt idx="30">
                  <c:v>44669</c:v>
                </c:pt>
                <c:pt idx="31">
                  <c:v>44674</c:v>
                </c:pt>
                <c:pt idx="32">
                  <c:v>44679</c:v>
                </c:pt>
                <c:pt idx="33">
                  <c:v>44684</c:v>
                </c:pt>
                <c:pt idx="34">
                  <c:v>44689</c:v>
                </c:pt>
                <c:pt idx="35">
                  <c:v>44694</c:v>
                </c:pt>
              </c:numCache>
            </c:numRef>
          </c:cat>
          <c:val>
            <c:numRef>
              <c:f>'graph 2'!$E$3:$E$38</c:f>
              <c:numCache>
                <c:formatCode>0.00</c:formatCode>
                <c:ptCount val="36"/>
                <c:pt idx="0">
                  <c:v>10.594583651438937</c:v>
                </c:pt>
                <c:pt idx="1">
                  <c:v>10.50798181700659</c:v>
                </c:pt>
                <c:pt idx="2">
                  <c:v>10.432553333370221</c:v>
                </c:pt>
                <c:pt idx="3">
                  <c:v>10.369439270325298</c:v>
                </c:pt>
                <c:pt idx="4">
                  <c:v>10.319664572000502</c:v>
                </c:pt>
                <c:pt idx="5">
                  <c:v>10.284087909447077</c:v>
                </c:pt>
                <c:pt idx="6">
                  <c:v>10.263355814156819</c:v>
                </c:pt>
                <c:pt idx="7">
                  <c:v>10.25786584316492</c:v>
                </c:pt>
                <c:pt idx="8">
                  <c:v>10.265333519309893</c:v>
                </c:pt>
                <c:pt idx="9">
                  <c:v>10.286403173234486</c:v>
                </c:pt>
                <c:pt idx="10">
                  <c:v>10.332705177480609</c:v>
                </c:pt>
                <c:pt idx="11">
                  <c:v>10.386690925275625</c:v>
                </c:pt>
                <c:pt idx="12">
                  <c:v>10.453907589780865</c:v>
                </c:pt>
                <c:pt idx="13">
                  <c:v>10.533312026969014</c:v>
                </c:pt>
                <c:pt idx="14">
                  <c:v>10.623749456768246</c:v>
                </c:pt>
                <c:pt idx="15">
                  <c:v>10.72400298155272</c:v>
                </c:pt>
                <c:pt idx="16">
                  <c:v>10.832838474217645</c:v>
                </c:pt>
                <c:pt idx="17">
                  <c:v>10.949042090350249</c:v>
                </c:pt>
                <c:pt idx="18">
                  <c:v>11.071448868665801</c:v>
                </c:pt>
                <c:pt idx="19">
                  <c:v>11.198961988834826</c:v>
                </c:pt>
                <c:pt idx="20">
                  <c:v>11.330563128503986</c:v>
                </c:pt>
                <c:pt idx="21">
                  <c:v>11.465314953131497</c:v>
                </c:pt>
                <c:pt idx="22">
                  <c:v>11.602357096938334</c:v>
                </c:pt>
                <c:pt idx="23">
                  <c:v>11.740897102615907</c:v>
                </c:pt>
                <c:pt idx="24">
                  <c:v>11.880197748411614</c:v>
                </c:pt>
                <c:pt idx="25">
                  <c:v>12.01956206910568</c:v>
                </c:pt>
                <c:pt idx="26">
                  <c:v>12.158317225865527</c:v>
                </c:pt>
                <c:pt idx="27">
                  <c:v>12.295798237011022</c:v>
                </c:pt>
                <c:pt idx="28">
                  <c:v>12.431332469397322</c:v>
                </c:pt>
                <c:pt idx="29">
                  <c:v>12.564225716195764</c:v>
                </c:pt>
                <c:pt idx="30">
                  <c:v>12.693750647096895</c:v>
                </c:pt>
                <c:pt idx="31">
                  <c:v>12.819138397373868</c:v>
                </c:pt>
                <c:pt idx="32">
                  <c:v>12.939574041174694</c:v>
                </c:pt>
                <c:pt idx="33">
                  <c:v>13.05419664487863</c:v>
                </c:pt>
                <c:pt idx="34">
                  <c:v>13.162104489145623</c:v>
                </c:pt>
                <c:pt idx="35">
                  <c:v>13.2623658563541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3C1-4242-8B61-8DEBA62883AA}"/>
            </c:ext>
          </c:extLst>
        </c:ser>
        <c:ser>
          <c:idx val="1"/>
          <c:order val="1"/>
          <c:tx>
            <c:v>Avg. temp. HiBAP I</c:v>
          </c:tx>
          <c:spPr>
            <a:ln w="158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'graph 2'!$D$3:$D$38</c:f>
              <c:numCache>
                <c:formatCode>d\-mmm</c:formatCode>
                <c:ptCount val="36"/>
                <c:pt idx="0">
                  <c:v>44519</c:v>
                </c:pt>
                <c:pt idx="1">
                  <c:v>44524</c:v>
                </c:pt>
                <c:pt idx="2">
                  <c:v>44529</c:v>
                </c:pt>
                <c:pt idx="3">
                  <c:v>44534</c:v>
                </c:pt>
                <c:pt idx="4">
                  <c:v>44539</c:v>
                </c:pt>
                <c:pt idx="5">
                  <c:v>44544</c:v>
                </c:pt>
                <c:pt idx="6">
                  <c:v>44549</c:v>
                </c:pt>
                <c:pt idx="7">
                  <c:v>44554</c:v>
                </c:pt>
                <c:pt idx="8">
                  <c:v>44559</c:v>
                </c:pt>
                <c:pt idx="9">
                  <c:v>44564</c:v>
                </c:pt>
                <c:pt idx="10">
                  <c:v>44569</c:v>
                </c:pt>
                <c:pt idx="11">
                  <c:v>44574</c:v>
                </c:pt>
                <c:pt idx="12">
                  <c:v>44579</c:v>
                </c:pt>
                <c:pt idx="13">
                  <c:v>44584</c:v>
                </c:pt>
                <c:pt idx="14">
                  <c:v>44589</c:v>
                </c:pt>
                <c:pt idx="15">
                  <c:v>44594</c:v>
                </c:pt>
                <c:pt idx="16">
                  <c:v>44599</c:v>
                </c:pt>
                <c:pt idx="17">
                  <c:v>44604</c:v>
                </c:pt>
                <c:pt idx="18">
                  <c:v>44609</c:v>
                </c:pt>
                <c:pt idx="19">
                  <c:v>44614</c:v>
                </c:pt>
                <c:pt idx="20">
                  <c:v>44619</c:v>
                </c:pt>
                <c:pt idx="21">
                  <c:v>44624</c:v>
                </c:pt>
                <c:pt idx="22">
                  <c:v>44629</c:v>
                </c:pt>
                <c:pt idx="23">
                  <c:v>44634</c:v>
                </c:pt>
                <c:pt idx="24">
                  <c:v>44639</c:v>
                </c:pt>
                <c:pt idx="25">
                  <c:v>44644</c:v>
                </c:pt>
                <c:pt idx="26">
                  <c:v>44649</c:v>
                </c:pt>
                <c:pt idx="27">
                  <c:v>44654</c:v>
                </c:pt>
                <c:pt idx="28">
                  <c:v>44659</c:v>
                </c:pt>
                <c:pt idx="29">
                  <c:v>44664</c:v>
                </c:pt>
                <c:pt idx="30">
                  <c:v>44669</c:v>
                </c:pt>
                <c:pt idx="31">
                  <c:v>44674</c:v>
                </c:pt>
                <c:pt idx="32">
                  <c:v>44679</c:v>
                </c:pt>
                <c:pt idx="33">
                  <c:v>44684</c:v>
                </c:pt>
                <c:pt idx="34">
                  <c:v>44689</c:v>
                </c:pt>
                <c:pt idx="35">
                  <c:v>44694</c:v>
                </c:pt>
              </c:numCache>
            </c:numRef>
          </c:cat>
          <c:val>
            <c:numRef>
              <c:f>'graph 2'!$F$3:$F$38</c:f>
              <c:numCache>
                <c:formatCode>General</c:formatCode>
                <c:ptCount val="36"/>
                <c:pt idx="3" formatCode="0.00">
                  <c:v>15.853750000000002</c:v>
                </c:pt>
                <c:pt idx="4" formatCode="0.00">
                  <c:v>18.286999999999999</c:v>
                </c:pt>
                <c:pt idx="5" formatCode="0.00">
                  <c:v>17.751999999999999</c:v>
                </c:pt>
                <c:pt idx="6" formatCode="0.00">
                  <c:v>16.384000000000004</c:v>
                </c:pt>
                <c:pt idx="7" formatCode="0.00">
                  <c:v>18.1585</c:v>
                </c:pt>
                <c:pt idx="8" formatCode="0.00">
                  <c:v>14.980500000000001</c:v>
                </c:pt>
                <c:pt idx="9" formatCode="0.00">
                  <c:v>15.816416666666665</c:v>
                </c:pt>
                <c:pt idx="10" formatCode="0.00">
                  <c:v>16.404083333333336</c:v>
                </c:pt>
                <c:pt idx="11" formatCode="0.00">
                  <c:v>15.383125000000001</c:v>
                </c:pt>
                <c:pt idx="12" formatCode="0.00">
                  <c:v>14.07833333333333</c:v>
                </c:pt>
                <c:pt idx="13" formatCode="0.00">
                  <c:v>15.301486111111108</c:v>
                </c:pt>
                <c:pt idx="14" formatCode="0.00">
                  <c:v>13.938319444444446</c:v>
                </c:pt>
                <c:pt idx="15" formatCode="0.00">
                  <c:v>15.670347222222228</c:v>
                </c:pt>
                <c:pt idx="16" formatCode="0.00">
                  <c:v>15.513013888888889</c:v>
                </c:pt>
                <c:pt idx="17" formatCode="0.00">
                  <c:v>18.832597222222223</c:v>
                </c:pt>
                <c:pt idx="18" formatCode="0.00">
                  <c:v>17.394444444444442</c:v>
                </c:pt>
                <c:pt idx="19" formatCode="0.00">
                  <c:v>18.228583333333329</c:v>
                </c:pt>
                <c:pt idx="20" formatCode="0.00">
                  <c:v>17.146265540015541</c:v>
                </c:pt>
                <c:pt idx="21" formatCode="0.00">
                  <c:v>18.154184523809526</c:v>
                </c:pt>
                <c:pt idx="22" formatCode="0.00">
                  <c:v>17.04752777777778</c:v>
                </c:pt>
                <c:pt idx="23" formatCode="0.00">
                  <c:v>19.232287439613533</c:v>
                </c:pt>
                <c:pt idx="24" formatCode="0.00">
                  <c:v>20.708847222222225</c:v>
                </c:pt>
                <c:pt idx="25" formatCode="0.00">
                  <c:v>20.340402777777779</c:v>
                </c:pt>
                <c:pt idx="26" formatCode="0.00">
                  <c:v>18.683541666666663</c:v>
                </c:pt>
                <c:pt idx="27" formatCode="0.00">
                  <c:v>18.383569444444447</c:v>
                </c:pt>
                <c:pt idx="28" formatCode="0.00">
                  <c:v>20.960277777777776</c:v>
                </c:pt>
                <c:pt idx="29" formatCode="0.00">
                  <c:v>20.978541666666665</c:v>
                </c:pt>
                <c:pt idx="30" formatCode="0.00">
                  <c:v>21.54729166666667</c:v>
                </c:pt>
                <c:pt idx="31" formatCode="0.00">
                  <c:v>23.230347222222221</c:v>
                </c:pt>
                <c:pt idx="32" formatCode="0.00">
                  <c:v>22.755208333333336</c:v>
                </c:pt>
                <c:pt idx="33" formatCode="0.00">
                  <c:v>22.45888888888889</c:v>
                </c:pt>
                <c:pt idx="34" formatCode="0.00">
                  <c:v>23.545138888888886</c:v>
                </c:pt>
                <c:pt idx="35" formatCode="0.00">
                  <c:v>23.9149305555555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3C1-4242-8B61-8DEBA62883AA}"/>
            </c:ext>
          </c:extLst>
        </c:ser>
        <c:ser>
          <c:idx val="2"/>
          <c:order val="2"/>
          <c:tx>
            <c:v>Avg. temp. HiBAP II</c:v>
          </c:tx>
          <c:spPr>
            <a:ln w="158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cat>
            <c:numRef>
              <c:f>'graph 2'!$D$3:$D$38</c:f>
              <c:numCache>
                <c:formatCode>d\-mmm</c:formatCode>
                <c:ptCount val="36"/>
                <c:pt idx="0">
                  <c:v>44519</c:v>
                </c:pt>
                <c:pt idx="1">
                  <c:v>44524</c:v>
                </c:pt>
                <c:pt idx="2">
                  <c:v>44529</c:v>
                </c:pt>
                <c:pt idx="3">
                  <c:v>44534</c:v>
                </c:pt>
                <c:pt idx="4">
                  <c:v>44539</c:v>
                </c:pt>
                <c:pt idx="5">
                  <c:v>44544</c:v>
                </c:pt>
                <c:pt idx="6">
                  <c:v>44549</c:v>
                </c:pt>
                <c:pt idx="7">
                  <c:v>44554</c:v>
                </c:pt>
                <c:pt idx="8">
                  <c:v>44559</c:v>
                </c:pt>
                <c:pt idx="9">
                  <c:v>44564</c:v>
                </c:pt>
                <c:pt idx="10">
                  <c:v>44569</c:v>
                </c:pt>
                <c:pt idx="11">
                  <c:v>44574</c:v>
                </c:pt>
                <c:pt idx="12">
                  <c:v>44579</c:v>
                </c:pt>
                <c:pt idx="13">
                  <c:v>44584</c:v>
                </c:pt>
                <c:pt idx="14">
                  <c:v>44589</c:v>
                </c:pt>
                <c:pt idx="15">
                  <c:v>44594</c:v>
                </c:pt>
                <c:pt idx="16">
                  <c:v>44599</c:v>
                </c:pt>
                <c:pt idx="17">
                  <c:v>44604</c:v>
                </c:pt>
                <c:pt idx="18">
                  <c:v>44609</c:v>
                </c:pt>
                <c:pt idx="19">
                  <c:v>44614</c:v>
                </c:pt>
                <c:pt idx="20">
                  <c:v>44619</c:v>
                </c:pt>
                <c:pt idx="21">
                  <c:v>44624</c:v>
                </c:pt>
                <c:pt idx="22">
                  <c:v>44629</c:v>
                </c:pt>
                <c:pt idx="23">
                  <c:v>44634</c:v>
                </c:pt>
                <c:pt idx="24">
                  <c:v>44639</c:v>
                </c:pt>
                <c:pt idx="25">
                  <c:v>44644</c:v>
                </c:pt>
                <c:pt idx="26">
                  <c:v>44649</c:v>
                </c:pt>
                <c:pt idx="27">
                  <c:v>44654</c:v>
                </c:pt>
                <c:pt idx="28">
                  <c:v>44659</c:v>
                </c:pt>
                <c:pt idx="29">
                  <c:v>44664</c:v>
                </c:pt>
                <c:pt idx="30">
                  <c:v>44669</c:v>
                </c:pt>
                <c:pt idx="31">
                  <c:v>44674</c:v>
                </c:pt>
                <c:pt idx="32">
                  <c:v>44679</c:v>
                </c:pt>
                <c:pt idx="33">
                  <c:v>44684</c:v>
                </c:pt>
                <c:pt idx="34">
                  <c:v>44689</c:v>
                </c:pt>
                <c:pt idx="35">
                  <c:v>44694</c:v>
                </c:pt>
              </c:numCache>
            </c:numRef>
          </c:cat>
          <c:val>
            <c:numRef>
              <c:f>'graph 2'!$G$3:$G$38</c:f>
              <c:numCache>
                <c:formatCode>General</c:formatCode>
                <c:ptCount val="36"/>
                <c:pt idx="2" formatCode="0.00">
                  <c:v>20.256999999999998</c:v>
                </c:pt>
                <c:pt idx="3" formatCode="0.00">
                  <c:v>18.964000000000002</c:v>
                </c:pt>
                <c:pt idx="4" formatCode="0.00">
                  <c:v>18.768000000000001</c:v>
                </c:pt>
                <c:pt idx="5" formatCode="0.00">
                  <c:v>18.557499999999997</c:v>
                </c:pt>
                <c:pt idx="6" formatCode="0.00">
                  <c:v>17.318000000000001</c:v>
                </c:pt>
                <c:pt idx="7" formatCode="0.00">
                  <c:v>16.709499999999998</c:v>
                </c:pt>
                <c:pt idx="8" formatCode="0.00">
                  <c:v>16.662999999999997</c:v>
                </c:pt>
                <c:pt idx="9" formatCode="0.00">
                  <c:v>14.507</c:v>
                </c:pt>
                <c:pt idx="10" formatCode="0.00">
                  <c:v>17.285000000000004</c:v>
                </c:pt>
                <c:pt idx="11" formatCode="0.00">
                  <c:v>17.411000000000001</c:v>
                </c:pt>
                <c:pt idx="12" formatCode="0.00">
                  <c:v>16.986499999999999</c:v>
                </c:pt>
                <c:pt idx="13" formatCode="0.00">
                  <c:v>16.151</c:v>
                </c:pt>
                <c:pt idx="14" formatCode="0.00">
                  <c:v>14.5535</c:v>
                </c:pt>
                <c:pt idx="15" formatCode="0.00">
                  <c:v>17.6875</c:v>
                </c:pt>
                <c:pt idx="16" formatCode="0.00">
                  <c:v>18.676499999999997</c:v>
                </c:pt>
                <c:pt idx="17" formatCode="0.00">
                  <c:v>16.361499999999999</c:v>
                </c:pt>
                <c:pt idx="18" formatCode="0.00">
                  <c:v>18.715499999999999</c:v>
                </c:pt>
                <c:pt idx="19" formatCode="0.00">
                  <c:v>14.717500000000001</c:v>
                </c:pt>
                <c:pt idx="20" formatCode="0.00">
                  <c:v>14.1555</c:v>
                </c:pt>
                <c:pt idx="21" formatCode="0.00">
                  <c:v>17.532</c:v>
                </c:pt>
                <c:pt idx="22" formatCode="0.00">
                  <c:v>17.794499999999999</c:v>
                </c:pt>
                <c:pt idx="23" formatCode="0.00">
                  <c:v>19.098000000000003</c:v>
                </c:pt>
                <c:pt idx="24" formatCode="0.00">
                  <c:v>17.8645</c:v>
                </c:pt>
                <c:pt idx="25" formatCode="0.00">
                  <c:v>19.160499999999999</c:v>
                </c:pt>
                <c:pt idx="26" formatCode="0.00">
                  <c:v>19.437000000000001</c:v>
                </c:pt>
                <c:pt idx="27" formatCode="0.00">
                  <c:v>19.353499999999997</c:v>
                </c:pt>
                <c:pt idx="28" formatCode="0.00">
                  <c:v>20.605499999999999</c:v>
                </c:pt>
                <c:pt idx="29" formatCode="0.00">
                  <c:v>20.829000000000001</c:v>
                </c:pt>
                <c:pt idx="30" formatCode="0.00">
                  <c:v>20.315000000000001</c:v>
                </c:pt>
                <c:pt idx="31" formatCode="0.00">
                  <c:v>21.999500000000001</c:v>
                </c:pt>
                <c:pt idx="32" formatCode="0.00">
                  <c:v>24.027000000000005</c:v>
                </c:pt>
                <c:pt idx="33" formatCode="0.00">
                  <c:v>22.020999999999997</c:v>
                </c:pt>
                <c:pt idx="34" formatCode="0.00">
                  <c:v>23.83</c:v>
                </c:pt>
                <c:pt idx="35" formatCode="0.00">
                  <c:v>23.1584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3C1-4242-8B61-8DEBA62883AA}"/>
            </c:ext>
          </c:extLst>
        </c:ser>
        <c:ser>
          <c:idx val="3"/>
          <c:order val="3"/>
          <c:tx>
            <c:v>Min. temp. HiBAP I</c:v>
          </c:tx>
          <c:spPr>
            <a:ln w="15875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graph 2'!$D$3:$D$38</c:f>
              <c:numCache>
                <c:formatCode>d\-mmm</c:formatCode>
                <c:ptCount val="36"/>
                <c:pt idx="0">
                  <c:v>44519</c:v>
                </c:pt>
                <c:pt idx="1">
                  <c:v>44524</c:v>
                </c:pt>
                <c:pt idx="2">
                  <c:v>44529</c:v>
                </c:pt>
                <c:pt idx="3">
                  <c:v>44534</c:v>
                </c:pt>
                <c:pt idx="4">
                  <c:v>44539</c:v>
                </c:pt>
                <c:pt idx="5">
                  <c:v>44544</c:v>
                </c:pt>
                <c:pt idx="6">
                  <c:v>44549</c:v>
                </c:pt>
                <c:pt idx="7">
                  <c:v>44554</c:v>
                </c:pt>
                <c:pt idx="8">
                  <c:v>44559</c:v>
                </c:pt>
                <c:pt idx="9">
                  <c:v>44564</c:v>
                </c:pt>
                <c:pt idx="10">
                  <c:v>44569</c:v>
                </c:pt>
                <c:pt idx="11">
                  <c:v>44574</c:v>
                </c:pt>
                <c:pt idx="12">
                  <c:v>44579</c:v>
                </c:pt>
                <c:pt idx="13">
                  <c:v>44584</c:v>
                </c:pt>
                <c:pt idx="14">
                  <c:v>44589</c:v>
                </c:pt>
                <c:pt idx="15">
                  <c:v>44594</c:v>
                </c:pt>
                <c:pt idx="16">
                  <c:v>44599</c:v>
                </c:pt>
                <c:pt idx="17">
                  <c:v>44604</c:v>
                </c:pt>
                <c:pt idx="18">
                  <c:v>44609</c:v>
                </c:pt>
                <c:pt idx="19">
                  <c:v>44614</c:v>
                </c:pt>
                <c:pt idx="20">
                  <c:v>44619</c:v>
                </c:pt>
                <c:pt idx="21">
                  <c:v>44624</c:v>
                </c:pt>
                <c:pt idx="22">
                  <c:v>44629</c:v>
                </c:pt>
                <c:pt idx="23">
                  <c:v>44634</c:v>
                </c:pt>
                <c:pt idx="24">
                  <c:v>44639</c:v>
                </c:pt>
                <c:pt idx="25">
                  <c:v>44644</c:v>
                </c:pt>
                <c:pt idx="26">
                  <c:v>44649</c:v>
                </c:pt>
                <c:pt idx="27">
                  <c:v>44654</c:v>
                </c:pt>
                <c:pt idx="28">
                  <c:v>44659</c:v>
                </c:pt>
                <c:pt idx="29">
                  <c:v>44664</c:v>
                </c:pt>
                <c:pt idx="30">
                  <c:v>44669</c:v>
                </c:pt>
                <c:pt idx="31">
                  <c:v>44674</c:v>
                </c:pt>
                <c:pt idx="32">
                  <c:v>44679</c:v>
                </c:pt>
                <c:pt idx="33">
                  <c:v>44684</c:v>
                </c:pt>
                <c:pt idx="34">
                  <c:v>44689</c:v>
                </c:pt>
                <c:pt idx="35">
                  <c:v>44694</c:v>
                </c:pt>
              </c:numCache>
            </c:numRef>
          </c:cat>
          <c:val>
            <c:numRef>
              <c:f>'graph 2'!$H$3:$H$38</c:f>
              <c:numCache>
                <c:formatCode>General</c:formatCode>
                <c:ptCount val="36"/>
                <c:pt idx="3" formatCode="0.00">
                  <c:v>8.4125000000000014</c:v>
                </c:pt>
                <c:pt idx="4" formatCode="0.00">
                  <c:v>9.86</c:v>
                </c:pt>
                <c:pt idx="5" formatCode="0.00">
                  <c:v>9.1</c:v>
                </c:pt>
                <c:pt idx="6" formatCode="0.00">
                  <c:v>9.4199999999999982</c:v>
                </c:pt>
                <c:pt idx="7" formatCode="0.00">
                  <c:v>11.847</c:v>
                </c:pt>
                <c:pt idx="8" formatCode="0.00">
                  <c:v>8.3510000000000009</c:v>
                </c:pt>
                <c:pt idx="9" formatCode="0.00">
                  <c:v>9.0109999999999992</c:v>
                </c:pt>
                <c:pt idx="10" formatCode="0.00">
                  <c:v>9.26</c:v>
                </c:pt>
                <c:pt idx="11" formatCode="0.00">
                  <c:v>7.85</c:v>
                </c:pt>
                <c:pt idx="12" formatCode="0.00">
                  <c:v>6.5</c:v>
                </c:pt>
                <c:pt idx="13" formatCode="0.00">
                  <c:v>7.4599999999999991</c:v>
                </c:pt>
                <c:pt idx="14" formatCode="0.00">
                  <c:v>6.49</c:v>
                </c:pt>
                <c:pt idx="15" formatCode="0.00">
                  <c:v>7.85</c:v>
                </c:pt>
                <c:pt idx="16" formatCode="0.00">
                  <c:v>7.33</c:v>
                </c:pt>
                <c:pt idx="17" formatCode="0.00">
                  <c:v>11.210000000000003</c:v>
                </c:pt>
                <c:pt idx="18" formatCode="0.00">
                  <c:v>10.09</c:v>
                </c:pt>
                <c:pt idx="19" formatCode="0.00">
                  <c:v>11.319999999999999</c:v>
                </c:pt>
                <c:pt idx="20" formatCode="0.00">
                  <c:v>8.56</c:v>
                </c:pt>
                <c:pt idx="21" formatCode="0.00">
                  <c:v>10.18</c:v>
                </c:pt>
                <c:pt idx="22" formatCode="0.00">
                  <c:v>9.9499999999999993</c:v>
                </c:pt>
                <c:pt idx="23" formatCode="0.00">
                  <c:v>10.75</c:v>
                </c:pt>
                <c:pt idx="24" formatCode="0.00">
                  <c:v>11.88</c:v>
                </c:pt>
                <c:pt idx="25" formatCode="0.00">
                  <c:v>11.790000000000001</c:v>
                </c:pt>
                <c:pt idx="26" formatCode="0.00">
                  <c:v>9.65</c:v>
                </c:pt>
                <c:pt idx="27" formatCode="0.00">
                  <c:v>10.119999999999999</c:v>
                </c:pt>
                <c:pt idx="28" formatCode="0.00">
                  <c:v>11.78</c:v>
                </c:pt>
                <c:pt idx="29" formatCode="0.00">
                  <c:v>11.080000000000002</c:v>
                </c:pt>
                <c:pt idx="30" formatCode="0.00">
                  <c:v>11.07</c:v>
                </c:pt>
                <c:pt idx="31" formatCode="0.00">
                  <c:v>12.069999999999999</c:v>
                </c:pt>
                <c:pt idx="32" formatCode="0.00">
                  <c:v>13.98</c:v>
                </c:pt>
                <c:pt idx="33" formatCode="0.00">
                  <c:v>12.37</c:v>
                </c:pt>
                <c:pt idx="34" formatCode="0.00">
                  <c:v>14.079999999999998</c:v>
                </c:pt>
                <c:pt idx="35" formatCode="0.00">
                  <c:v>13.28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3C1-4242-8B61-8DEBA62883AA}"/>
            </c:ext>
          </c:extLst>
        </c:ser>
        <c:ser>
          <c:idx val="4"/>
          <c:order val="4"/>
          <c:tx>
            <c:v>Max. temp. HiBAP I</c:v>
          </c:tx>
          <c:spPr>
            <a:ln w="15875" cap="rnd">
              <a:solidFill>
                <a:schemeClr val="accent5"/>
              </a:solidFill>
              <a:prstDash val="dashDot"/>
              <a:round/>
            </a:ln>
            <a:effectLst/>
          </c:spPr>
          <c:marker>
            <c:symbol val="none"/>
          </c:marker>
          <c:cat>
            <c:numRef>
              <c:f>'graph 2'!$D$3:$D$38</c:f>
              <c:numCache>
                <c:formatCode>d\-mmm</c:formatCode>
                <c:ptCount val="36"/>
                <c:pt idx="0">
                  <c:v>44519</c:v>
                </c:pt>
                <c:pt idx="1">
                  <c:v>44524</c:v>
                </c:pt>
                <c:pt idx="2">
                  <c:v>44529</c:v>
                </c:pt>
                <c:pt idx="3">
                  <c:v>44534</c:v>
                </c:pt>
                <c:pt idx="4">
                  <c:v>44539</c:v>
                </c:pt>
                <c:pt idx="5">
                  <c:v>44544</c:v>
                </c:pt>
                <c:pt idx="6">
                  <c:v>44549</c:v>
                </c:pt>
                <c:pt idx="7">
                  <c:v>44554</c:v>
                </c:pt>
                <c:pt idx="8">
                  <c:v>44559</c:v>
                </c:pt>
                <c:pt idx="9">
                  <c:v>44564</c:v>
                </c:pt>
                <c:pt idx="10">
                  <c:v>44569</c:v>
                </c:pt>
                <c:pt idx="11">
                  <c:v>44574</c:v>
                </c:pt>
                <c:pt idx="12">
                  <c:v>44579</c:v>
                </c:pt>
                <c:pt idx="13">
                  <c:v>44584</c:v>
                </c:pt>
                <c:pt idx="14">
                  <c:v>44589</c:v>
                </c:pt>
                <c:pt idx="15">
                  <c:v>44594</c:v>
                </c:pt>
                <c:pt idx="16">
                  <c:v>44599</c:v>
                </c:pt>
                <c:pt idx="17">
                  <c:v>44604</c:v>
                </c:pt>
                <c:pt idx="18">
                  <c:v>44609</c:v>
                </c:pt>
                <c:pt idx="19">
                  <c:v>44614</c:v>
                </c:pt>
                <c:pt idx="20">
                  <c:v>44619</c:v>
                </c:pt>
                <c:pt idx="21">
                  <c:v>44624</c:v>
                </c:pt>
                <c:pt idx="22">
                  <c:v>44629</c:v>
                </c:pt>
                <c:pt idx="23">
                  <c:v>44634</c:v>
                </c:pt>
                <c:pt idx="24">
                  <c:v>44639</c:v>
                </c:pt>
                <c:pt idx="25">
                  <c:v>44644</c:v>
                </c:pt>
                <c:pt idx="26">
                  <c:v>44649</c:v>
                </c:pt>
                <c:pt idx="27">
                  <c:v>44654</c:v>
                </c:pt>
                <c:pt idx="28">
                  <c:v>44659</c:v>
                </c:pt>
                <c:pt idx="29">
                  <c:v>44664</c:v>
                </c:pt>
                <c:pt idx="30">
                  <c:v>44669</c:v>
                </c:pt>
                <c:pt idx="31">
                  <c:v>44674</c:v>
                </c:pt>
                <c:pt idx="32">
                  <c:v>44679</c:v>
                </c:pt>
                <c:pt idx="33">
                  <c:v>44684</c:v>
                </c:pt>
                <c:pt idx="34">
                  <c:v>44689</c:v>
                </c:pt>
                <c:pt idx="35">
                  <c:v>44694</c:v>
                </c:pt>
              </c:numCache>
            </c:numRef>
          </c:cat>
          <c:val>
            <c:numRef>
              <c:f>'graph 2'!$I$3:$I$38</c:f>
              <c:numCache>
                <c:formatCode>General</c:formatCode>
                <c:ptCount val="36"/>
                <c:pt idx="3" formatCode="0.00">
                  <c:v>25.175000000000001</c:v>
                </c:pt>
                <c:pt idx="4" formatCode="0.00">
                  <c:v>28.869999999999997</c:v>
                </c:pt>
                <c:pt idx="5" formatCode="0.00">
                  <c:v>28.28</c:v>
                </c:pt>
                <c:pt idx="6" formatCode="0.00">
                  <c:v>25.099999999999998</c:v>
                </c:pt>
                <c:pt idx="7" formatCode="0.00">
                  <c:v>25.701999999999998</c:v>
                </c:pt>
                <c:pt idx="8" formatCode="0.00">
                  <c:v>21.846000000000004</c:v>
                </c:pt>
                <c:pt idx="9" formatCode="0.00">
                  <c:v>24.029999999999998</c:v>
                </c:pt>
                <c:pt idx="10" formatCode="0.00">
                  <c:v>25.380000000000003</c:v>
                </c:pt>
                <c:pt idx="11" formatCode="0.00">
                  <c:v>25.06</c:v>
                </c:pt>
                <c:pt idx="12" formatCode="0.00">
                  <c:v>23.47</c:v>
                </c:pt>
                <c:pt idx="13" formatCode="0.00">
                  <c:v>25.71</c:v>
                </c:pt>
                <c:pt idx="14" formatCode="0.00">
                  <c:v>23.86</c:v>
                </c:pt>
                <c:pt idx="15" formatCode="0.00">
                  <c:v>25.880000000000003</c:v>
                </c:pt>
                <c:pt idx="16" formatCode="0.00">
                  <c:v>26.29</c:v>
                </c:pt>
                <c:pt idx="17" formatCode="0.00">
                  <c:v>29.4</c:v>
                </c:pt>
                <c:pt idx="18" formatCode="0.00">
                  <c:v>26.860000000000003</c:v>
                </c:pt>
                <c:pt idx="19" formatCode="0.00">
                  <c:v>27.389999999999997</c:v>
                </c:pt>
                <c:pt idx="20" formatCode="0.00">
                  <c:v>27.82</c:v>
                </c:pt>
                <c:pt idx="21" formatCode="0.00">
                  <c:v>27.189999999999998</c:v>
                </c:pt>
                <c:pt idx="22" formatCode="0.00">
                  <c:v>27.02</c:v>
                </c:pt>
                <c:pt idx="23" formatCode="0.00">
                  <c:v>28.579999999999995</c:v>
                </c:pt>
                <c:pt idx="24" formatCode="0.00">
                  <c:v>30.079999999999995</c:v>
                </c:pt>
                <c:pt idx="25" formatCode="0.00">
                  <c:v>30.119999999999997</c:v>
                </c:pt>
                <c:pt idx="26" formatCode="0.00">
                  <c:v>28.590000000000003</c:v>
                </c:pt>
                <c:pt idx="27" formatCode="0.00">
                  <c:v>27.639999999999997</c:v>
                </c:pt>
                <c:pt idx="28" formatCode="0.00">
                  <c:v>31.6</c:v>
                </c:pt>
                <c:pt idx="29" formatCode="0.00">
                  <c:v>32.35</c:v>
                </c:pt>
                <c:pt idx="30" formatCode="0.00">
                  <c:v>33.040000000000006</c:v>
                </c:pt>
                <c:pt idx="31" formatCode="0.00">
                  <c:v>35.010000000000005</c:v>
                </c:pt>
                <c:pt idx="32" formatCode="0.00">
                  <c:v>32.04</c:v>
                </c:pt>
                <c:pt idx="33" formatCode="0.00">
                  <c:v>33.029999999999994</c:v>
                </c:pt>
                <c:pt idx="34" formatCode="0.00">
                  <c:v>33.199999999999996</c:v>
                </c:pt>
                <c:pt idx="35" formatCode="0.00">
                  <c:v>33.54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3C1-4242-8B61-8DEBA62883AA}"/>
            </c:ext>
          </c:extLst>
        </c:ser>
        <c:ser>
          <c:idx val="5"/>
          <c:order val="5"/>
          <c:tx>
            <c:v>Min. temp. HiBAP II</c:v>
          </c:tx>
          <c:spPr>
            <a:ln w="15875" cap="rnd">
              <a:solidFill>
                <a:srgbClr val="00B050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graph 2'!$D$3:$D$38</c:f>
              <c:numCache>
                <c:formatCode>d\-mmm</c:formatCode>
                <c:ptCount val="36"/>
                <c:pt idx="0">
                  <c:v>44519</c:v>
                </c:pt>
                <c:pt idx="1">
                  <c:v>44524</c:v>
                </c:pt>
                <c:pt idx="2">
                  <c:v>44529</c:v>
                </c:pt>
                <c:pt idx="3">
                  <c:v>44534</c:v>
                </c:pt>
                <c:pt idx="4">
                  <c:v>44539</c:v>
                </c:pt>
                <c:pt idx="5">
                  <c:v>44544</c:v>
                </c:pt>
                <c:pt idx="6">
                  <c:v>44549</c:v>
                </c:pt>
                <c:pt idx="7">
                  <c:v>44554</c:v>
                </c:pt>
                <c:pt idx="8">
                  <c:v>44559</c:v>
                </c:pt>
                <c:pt idx="9">
                  <c:v>44564</c:v>
                </c:pt>
                <c:pt idx="10">
                  <c:v>44569</c:v>
                </c:pt>
                <c:pt idx="11">
                  <c:v>44574</c:v>
                </c:pt>
                <c:pt idx="12">
                  <c:v>44579</c:v>
                </c:pt>
                <c:pt idx="13">
                  <c:v>44584</c:v>
                </c:pt>
                <c:pt idx="14">
                  <c:v>44589</c:v>
                </c:pt>
                <c:pt idx="15">
                  <c:v>44594</c:v>
                </c:pt>
                <c:pt idx="16">
                  <c:v>44599</c:v>
                </c:pt>
                <c:pt idx="17">
                  <c:v>44604</c:v>
                </c:pt>
                <c:pt idx="18">
                  <c:v>44609</c:v>
                </c:pt>
                <c:pt idx="19">
                  <c:v>44614</c:v>
                </c:pt>
                <c:pt idx="20">
                  <c:v>44619</c:v>
                </c:pt>
                <c:pt idx="21">
                  <c:v>44624</c:v>
                </c:pt>
                <c:pt idx="22">
                  <c:v>44629</c:v>
                </c:pt>
                <c:pt idx="23">
                  <c:v>44634</c:v>
                </c:pt>
                <c:pt idx="24">
                  <c:v>44639</c:v>
                </c:pt>
                <c:pt idx="25">
                  <c:v>44644</c:v>
                </c:pt>
                <c:pt idx="26">
                  <c:v>44649</c:v>
                </c:pt>
                <c:pt idx="27">
                  <c:v>44654</c:v>
                </c:pt>
                <c:pt idx="28">
                  <c:v>44659</c:v>
                </c:pt>
                <c:pt idx="29">
                  <c:v>44664</c:v>
                </c:pt>
                <c:pt idx="30">
                  <c:v>44669</c:v>
                </c:pt>
                <c:pt idx="31">
                  <c:v>44674</c:v>
                </c:pt>
                <c:pt idx="32">
                  <c:v>44679</c:v>
                </c:pt>
                <c:pt idx="33">
                  <c:v>44684</c:v>
                </c:pt>
                <c:pt idx="34">
                  <c:v>44689</c:v>
                </c:pt>
                <c:pt idx="35">
                  <c:v>44694</c:v>
                </c:pt>
              </c:numCache>
            </c:numRef>
          </c:cat>
          <c:val>
            <c:numRef>
              <c:f>'graph 2'!$J$3:$J$38</c:f>
              <c:numCache>
                <c:formatCode>General</c:formatCode>
                <c:ptCount val="36"/>
                <c:pt idx="2" formatCode="0.00">
                  <c:v>11.833</c:v>
                </c:pt>
                <c:pt idx="3" formatCode="0.00">
                  <c:v>11.396000000000001</c:v>
                </c:pt>
                <c:pt idx="4" formatCode="0.00">
                  <c:v>12.306000000000001</c:v>
                </c:pt>
                <c:pt idx="5" formatCode="0.00">
                  <c:v>11.125999999999999</c:v>
                </c:pt>
                <c:pt idx="6" formatCode="0.00">
                  <c:v>10.094999999999999</c:v>
                </c:pt>
                <c:pt idx="7" formatCode="0.00">
                  <c:v>6.9260000000000002</c:v>
                </c:pt>
                <c:pt idx="8" formatCode="0.00">
                  <c:v>8.6050000000000004</c:v>
                </c:pt>
                <c:pt idx="9" formatCode="0.00">
                  <c:v>5.6419999999999995</c:v>
                </c:pt>
                <c:pt idx="10" formatCode="0.00">
                  <c:v>9.782</c:v>
                </c:pt>
                <c:pt idx="11" formatCode="0.00">
                  <c:v>9.4419999999999984</c:v>
                </c:pt>
                <c:pt idx="12" formatCode="0.00">
                  <c:v>8.44</c:v>
                </c:pt>
                <c:pt idx="13" formatCode="0.00">
                  <c:v>7.0230000000000006</c:v>
                </c:pt>
                <c:pt idx="14" formatCode="0.00">
                  <c:v>3.8359999999999999</c:v>
                </c:pt>
                <c:pt idx="15" formatCode="0.00">
                  <c:v>9.8069999999999986</c:v>
                </c:pt>
                <c:pt idx="16" formatCode="0.00">
                  <c:v>12.379</c:v>
                </c:pt>
                <c:pt idx="17" formatCode="0.00">
                  <c:v>9.2409999999999997</c:v>
                </c:pt>
                <c:pt idx="18" formatCode="0.00">
                  <c:v>11.641</c:v>
                </c:pt>
                <c:pt idx="19" formatCode="0.00">
                  <c:v>8.1479999999999997</c:v>
                </c:pt>
                <c:pt idx="20" formatCode="0.00">
                  <c:v>5.2200000000000006</c:v>
                </c:pt>
                <c:pt idx="21" formatCode="0.00">
                  <c:v>8.4719999999999995</c:v>
                </c:pt>
                <c:pt idx="22" formatCode="0.00">
                  <c:v>9.1820000000000004</c:v>
                </c:pt>
                <c:pt idx="23" formatCode="0.00">
                  <c:v>11.783000000000001</c:v>
                </c:pt>
                <c:pt idx="24" formatCode="0.00">
                  <c:v>9.270999999999999</c:v>
                </c:pt>
                <c:pt idx="25" formatCode="0.00">
                  <c:v>8.85</c:v>
                </c:pt>
                <c:pt idx="26" formatCode="0.00">
                  <c:v>10.372</c:v>
                </c:pt>
                <c:pt idx="27" formatCode="0.00">
                  <c:v>9.2509999999999994</c:v>
                </c:pt>
                <c:pt idx="28" formatCode="0.00">
                  <c:v>10.257000000000001</c:v>
                </c:pt>
                <c:pt idx="29" formatCode="0.00">
                  <c:v>12.243</c:v>
                </c:pt>
                <c:pt idx="30" formatCode="0.00">
                  <c:v>10.077000000000002</c:v>
                </c:pt>
                <c:pt idx="31" formatCode="0.00">
                  <c:v>11.942</c:v>
                </c:pt>
                <c:pt idx="32" formatCode="0.00">
                  <c:v>13.062999999999999</c:v>
                </c:pt>
                <c:pt idx="33" formatCode="0.00">
                  <c:v>12.548</c:v>
                </c:pt>
                <c:pt idx="34" formatCode="0.00">
                  <c:v>13.507</c:v>
                </c:pt>
                <c:pt idx="35" formatCode="0.00">
                  <c:v>14.2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B3C1-4242-8B61-8DEBA62883AA}"/>
            </c:ext>
          </c:extLst>
        </c:ser>
        <c:ser>
          <c:idx val="6"/>
          <c:order val="6"/>
          <c:tx>
            <c:v>Max. temp. HiBAP II</c:v>
          </c:tx>
          <c:spPr>
            <a:ln w="15875" cap="rnd">
              <a:solidFill>
                <a:srgbClr val="00B050"/>
              </a:solidFill>
              <a:prstDash val="dashDot"/>
              <a:round/>
            </a:ln>
            <a:effectLst/>
          </c:spPr>
          <c:marker>
            <c:symbol val="none"/>
          </c:marker>
          <c:cat>
            <c:numRef>
              <c:f>'graph 2'!$D$3:$D$38</c:f>
              <c:numCache>
                <c:formatCode>d\-mmm</c:formatCode>
                <c:ptCount val="36"/>
                <c:pt idx="0">
                  <c:v>44519</c:v>
                </c:pt>
                <c:pt idx="1">
                  <c:v>44524</c:v>
                </c:pt>
                <c:pt idx="2">
                  <c:v>44529</c:v>
                </c:pt>
                <c:pt idx="3">
                  <c:v>44534</c:v>
                </c:pt>
                <c:pt idx="4">
                  <c:v>44539</c:v>
                </c:pt>
                <c:pt idx="5">
                  <c:v>44544</c:v>
                </c:pt>
                <c:pt idx="6">
                  <c:v>44549</c:v>
                </c:pt>
                <c:pt idx="7">
                  <c:v>44554</c:v>
                </c:pt>
                <c:pt idx="8">
                  <c:v>44559</c:v>
                </c:pt>
                <c:pt idx="9">
                  <c:v>44564</c:v>
                </c:pt>
                <c:pt idx="10">
                  <c:v>44569</c:v>
                </c:pt>
                <c:pt idx="11">
                  <c:v>44574</c:v>
                </c:pt>
                <c:pt idx="12">
                  <c:v>44579</c:v>
                </c:pt>
                <c:pt idx="13">
                  <c:v>44584</c:v>
                </c:pt>
                <c:pt idx="14">
                  <c:v>44589</c:v>
                </c:pt>
                <c:pt idx="15">
                  <c:v>44594</c:v>
                </c:pt>
                <c:pt idx="16">
                  <c:v>44599</c:v>
                </c:pt>
                <c:pt idx="17">
                  <c:v>44604</c:v>
                </c:pt>
                <c:pt idx="18">
                  <c:v>44609</c:v>
                </c:pt>
                <c:pt idx="19">
                  <c:v>44614</c:v>
                </c:pt>
                <c:pt idx="20">
                  <c:v>44619</c:v>
                </c:pt>
                <c:pt idx="21">
                  <c:v>44624</c:v>
                </c:pt>
                <c:pt idx="22">
                  <c:v>44629</c:v>
                </c:pt>
                <c:pt idx="23">
                  <c:v>44634</c:v>
                </c:pt>
                <c:pt idx="24">
                  <c:v>44639</c:v>
                </c:pt>
                <c:pt idx="25">
                  <c:v>44644</c:v>
                </c:pt>
                <c:pt idx="26">
                  <c:v>44649</c:v>
                </c:pt>
                <c:pt idx="27">
                  <c:v>44654</c:v>
                </c:pt>
                <c:pt idx="28">
                  <c:v>44659</c:v>
                </c:pt>
                <c:pt idx="29">
                  <c:v>44664</c:v>
                </c:pt>
                <c:pt idx="30">
                  <c:v>44669</c:v>
                </c:pt>
                <c:pt idx="31">
                  <c:v>44674</c:v>
                </c:pt>
                <c:pt idx="32">
                  <c:v>44679</c:v>
                </c:pt>
                <c:pt idx="33">
                  <c:v>44684</c:v>
                </c:pt>
                <c:pt idx="34">
                  <c:v>44689</c:v>
                </c:pt>
                <c:pt idx="35">
                  <c:v>44694</c:v>
                </c:pt>
              </c:numCache>
            </c:numRef>
          </c:cat>
          <c:val>
            <c:numRef>
              <c:f>'graph 2'!$K$3:$K$38</c:f>
              <c:numCache>
                <c:formatCode>General</c:formatCode>
                <c:ptCount val="36"/>
                <c:pt idx="2" formatCode="0.00">
                  <c:v>29.506</c:v>
                </c:pt>
                <c:pt idx="3" formatCode="0.00">
                  <c:v>27.57</c:v>
                </c:pt>
                <c:pt idx="4" formatCode="0.00">
                  <c:v>25.904999999999994</c:v>
                </c:pt>
                <c:pt idx="5" formatCode="0.00">
                  <c:v>27.237000000000002</c:v>
                </c:pt>
                <c:pt idx="6" formatCode="0.00">
                  <c:v>25.113000000000003</c:v>
                </c:pt>
                <c:pt idx="7" formatCode="0.00">
                  <c:v>27.474</c:v>
                </c:pt>
                <c:pt idx="8" formatCode="0.00">
                  <c:v>26.060999999999996</c:v>
                </c:pt>
                <c:pt idx="9" formatCode="0.00">
                  <c:v>24.617000000000001</c:v>
                </c:pt>
                <c:pt idx="10" formatCode="0.00">
                  <c:v>26.233000000000004</c:v>
                </c:pt>
                <c:pt idx="11" formatCode="0.00">
                  <c:v>26.522000000000002</c:v>
                </c:pt>
                <c:pt idx="12" formatCode="0.00">
                  <c:v>27.054000000000002</c:v>
                </c:pt>
                <c:pt idx="13" formatCode="0.00">
                  <c:v>26.490000000000002</c:v>
                </c:pt>
                <c:pt idx="14" formatCode="0.00">
                  <c:v>26.619</c:v>
                </c:pt>
                <c:pt idx="15" formatCode="0.00">
                  <c:v>26.442</c:v>
                </c:pt>
                <c:pt idx="16" formatCode="0.00">
                  <c:v>26.113999999999997</c:v>
                </c:pt>
                <c:pt idx="17" formatCode="0.00">
                  <c:v>24.614999999999998</c:v>
                </c:pt>
                <c:pt idx="18" formatCode="0.00">
                  <c:v>26.713000000000001</c:v>
                </c:pt>
                <c:pt idx="19" formatCode="0.00">
                  <c:v>21.550999999999998</c:v>
                </c:pt>
                <c:pt idx="20" formatCode="0.00">
                  <c:v>24.258000000000003</c:v>
                </c:pt>
                <c:pt idx="21" formatCode="0.00">
                  <c:v>28.024999999999999</c:v>
                </c:pt>
                <c:pt idx="22" formatCode="0.00">
                  <c:v>28.067</c:v>
                </c:pt>
                <c:pt idx="23" formatCode="0.00">
                  <c:v>27.409000000000002</c:v>
                </c:pt>
                <c:pt idx="24" formatCode="0.00">
                  <c:v>26.878000000000004</c:v>
                </c:pt>
                <c:pt idx="25" formatCode="0.00">
                  <c:v>30.663</c:v>
                </c:pt>
                <c:pt idx="26" formatCode="0.00">
                  <c:v>29.977999999999998</c:v>
                </c:pt>
                <c:pt idx="27" formatCode="0.00">
                  <c:v>30.165000000000003</c:v>
                </c:pt>
                <c:pt idx="28" formatCode="0.00">
                  <c:v>31.355</c:v>
                </c:pt>
                <c:pt idx="29" formatCode="0.00">
                  <c:v>30.235000000000003</c:v>
                </c:pt>
                <c:pt idx="30" formatCode="0.00">
                  <c:v>31.148000000000003</c:v>
                </c:pt>
                <c:pt idx="31" formatCode="0.00">
                  <c:v>32.213999999999999</c:v>
                </c:pt>
                <c:pt idx="32" formatCode="0.00">
                  <c:v>34.823</c:v>
                </c:pt>
                <c:pt idx="33" formatCode="0.00">
                  <c:v>31.459999999999997</c:v>
                </c:pt>
                <c:pt idx="34" formatCode="0.00">
                  <c:v>34.167999999999999</c:v>
                </c:pt>
                <c:pt idx="35" formatCode="0.00">
                  <c:v>32.41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B3C1-4242-8B61-8DEBA62883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6501088"/>
        <c:axId val="26501504"/>
      </c:lineChart>
      <c:dateAx>
        <c:axId val="26501088"/>
        <c:scaling>
          <c:orientation val="minMax"/>
        </c:scaling>
        <c:delete val="0"/>
        <c:axPos val="b"/>
        <c:numFmt formatCode="d\-mmm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01504"/>
        <c:crosses val="autoZero"/>
        <c:auto val="1"/>
        <c:lblOffset val="100"/>
        <c:baseTimeUnit val="days"/>
      </c:dateAx>
      <c:valAx>
        <c:axId val="265015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010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1595961255547372E-2"/>
          <c:y val="0.88317159474147355"/>
          <c:w val="0.96525254111314263"/>
          <c:h val="9.85024940795522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15684D-11E7-48BA-A349-FF012556A7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2DB6F1-2F99-4EB2-8F06-632BA5E7B1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C5EE72-4637-47D0-8CC6-D2C7B48C6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132512-B5F5-4F56-9A82-A153A9035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933195-F80A-4409-833B-4E9586857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36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DF6234-6A9F-4486-8B3C-690835BB3B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0164F4-70E2-465E-A619-7830EBB551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9E5EA-0F52-4D54-AE7E-FAD67AA1E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F30335-1BEA-4A63-934A-A622313A7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EFAEA5-0FD1-436D-87A1-1F5571669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466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05ABF7-A1CF-4731-9ABF-0FAE7FF926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1A47AD-6099-46B4-B101-C7478DB61A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543711-DCD7-4BCA-B5F4-E920044AB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056AFB-B3CD-4275-80B4-3933C4E0D6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45829-3E75-4777-8166-9F4D3C1AF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607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797D51-DA30-4D2C-BA99-36FAC5DC09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556F5D-80E6-42B2-8B46-F946753BFD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A3FEFA-9AA0-4ABA-9839-FB8DBF874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17B43C-4156-428A-B269-FF084F4CA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791274-0952-4C3E-928F-574D319AC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269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FF1F9D-EC21-4071-9F82-58146E71B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8755C5-D736-4B74-8CC6-0342B5DA9E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84A9A2-5BD4-478A-8589-B2743E49F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5EAF7C-D715-4071-B414-7B5ABC6B2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645AB4-E4B1-401B-8187-3A55429B5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984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C96BD-D14F-4E18-83C9-38536BCA9F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B51958-D272-4D27-89E3-9CFDA5F802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B90E88-CD7E-4A11-A7C1-EC54FE6CAC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34249C-9479-42B6-BBBE-2315AED8C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914F9F-FA1F-4C96-A13E-7906BB092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26972A-AF0C-4842-A3CF-321045FDCE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09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6E330-3C88-4289-B5F4-A2FB60C82B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34C64F-2AD5-4165-92E7-66BC776D8E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5543C0-55E2-4F78-9F4A-A8334F6CC9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33EF480-30B6-4BC0-AAD6-CD486D7869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79BB17-B2C2-46F9-B869-D838F363AE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22B9FC2-6F98-4EBD-9472-F7C75B78D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D697A4-6E33-4434-8F74-A7514EF6A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315B67-19DD-4AB7-AFA9-F55A53516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01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D6A6E-053F-41C3-B215-1724F3B3AA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1340CA-9C62-4FCB-86F5-0575E4931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8AE1CAF-D160-4523-85FA-A270B023F7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2BDCBB-2C54-47E7-A6FD-499C37EC3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80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B0CD363-7752-4C0D-849C-ABB2CF933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E5E53A1-6E2F-43F3-B66C-9FF6DF8F8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DC10AF-22E3-4873-B98E-F59EC6A8D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96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38F9B1-EFA4-41E7-BDD5-05AFE89C63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6EB5A3-CDA6-4D0A-9ED9-CD08673B6A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75B7B4-B199-46A3-BCBA-2DD2579BD7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E4598A-C802-4958-93C9-450E7DEA4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F687BD-DDEC-4183-8362-6A48884F5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2638E7-46D5-4DA1-8131-8CD924CD4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032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6B3D1B-6D4D-4E79-B9FC-D647C1FF7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7DDF3D-7ED2-4F69-8A1F-3F3CB94D47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FA06CA-2A3A-49E6-B6E6-58B048B4FC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E25B2A-E68F-4A60-884A-FCDC6E276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002202-60D2-4CD2-B581-1506BD7DF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D62E04-2CFD-49C9-AE43-6329CA5D4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884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98F95A-BE1B-48C8-A0EB-2E9E3E4EF8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20D4DD-567F-48BB-9BF5-0E1FCFD027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70AFAD-4420-45D5-9235-0D6BB0723E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7648D-20FB-4CC7-896C-02F2776C270E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5294A7-631C-4B3F-998E-45668B3DBB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E3FF99-E3A3-4CB0-8A65-1150D3603C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8FFA6-2EB3-4A4D-AE45-B107036B4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146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81FEEB48-8136-48DE-B98E-BC5EF6F198E4}"/>
              </a:ext>
            </a:extLst>
          </p:cNvPr>
          <p:cNvGraphicFramePr>
            <a:graphicFrameLocks/>
          </p:cNvGraphicFramePr>
          <p:nvPr/>
        </p:nvGraphicFramePr>
        <p:xfrm>
          <a:off x="2001324" y="974391"/>
          <a:ext cx="7693282" cy="41580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5EFB6BFE-57F1-4EF6-82D5-8C08FF30A953}"/>
              </a:ext>
            </a:extLst>
          </p:cNvPr>
          <p:cNvSpPr txBox="1"/>
          <p:nvPr/>
        </p:nvSpPr>
        <p:spPr>
          <a:xfrm>
            <a:off x="1825301" y="5166082"/>
            <a:ext cx="7785271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length and average, min., and max. daily temperature during the crop cycles 2015-16, 2016-17 fo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BA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 and 2017-18 and 2018-19 fo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BA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I.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TIn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Days to initiation of booting, DTA: Days to Anthesis, DTM: Days to maturity, VGP: Vegetative growth period, GFD: Grain filling duration. 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FB4774F-C58A-43DE-AFA4-A4DDA57D7F49}"/>
              </a:ext>
            </a:extLst>
          </p:cNvPr>
          <p:cNvCxnSpPr>
            <a:cxnSpLocks/>
          </p:cNvCxnSpPr>
          <p:nvPr/>
        </p:nvCxnSpPr>
        <p:spPr>
          <a:xfrm>
            <a:off x="2596128" y="1102679"/>
            <a:ext cx="0" cy="301752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4315115B-759C-4ACB-94F4-E7E8E7A1EA20}"/>
              </a:ext>
            </a:extLst>
          </p:cNvPr>
          <p:cNvCxnSpPr>
            <a:cxnSpLocks/>
          </p:cNvCxnSpPr>
          <p:nvPr/>
        </p:nvCxnSpPr>
        <p:spPr>
          <a:xfrm>
            <a:off x="2711313" y="1102679"/>
            <a:ext cx="0" cy="3017520"/>
          </a:xfrm>
          <a:prstGeom prst="line">
            <a:avLst/>
          </a:prstGeom>
          <a:ln>
            <a:solidFill>
              <a:srgbClr val="00B05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1908B732-B25E-41DF-B36B-4D777FE12E33}"/>
              </a:ext>
            </a:extLst>
          </p:cNvPr>
          <p:cNvSpPr txBox="1"/>
          <p:nvPr/>
        </p:nvSpPr>
        <p:spPr>
          <a:xfrm>
            <a:off x="2371954" y="850856"/>
            <a:ext cx="605661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50" dirty="0"/>
              <a:t>Sowing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FF3DE389-43CF-440E-A9F5-16F73895A97E}"/>
              </a:ext>
            </a:extLst>
          </p:cNvPr>
          <p:cNvCxnSpPr>
            <a:cxnSpLocks/>
          </p:cNvCxnSpPr>
          <p:nvPr/>
        </p:nvCxnSpPr>
        <p:spPr>
          <a:xfrm>
            <a:off x="5401066" y="1102245"/>
            <a:ext cx="0" cy="301752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A6A15F3C-A36D-4BD3-BC23-F57864280A52}"/>
              </a:ext>
            </a:extLst>
          </p:cNvPr>
          <p:cNvCxnSpPr>
            <a:cxnSpLocks/>
          </p:cNvCxnSpPr>
          <p:nvPr/>
        </p:nvCxnSpPr>
        <p:spPr>
          <a:xfrm>
            <a:off x="5482246" y="1102245"/>
            <a:ext cx="0" cy="3017520"/>
          </a:xfrm>
          <a:prstGeom prst="line">
            <a:avLst/>
          </a:prstGeom>
          <a:ln>
            <a:solidFill>
              <a:srgbClr val="00B05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C211753C-AFD8-4977-94C3-1209D3927C54}"/>
              </a:ext>
            </a:extLst>
          </p:cNvPr>
          <p:cNvCxnSpPr>
            <a:cxnSpLocks/>
          </p:cNvCxnSpPr>
          <p:nvPr/>
        </p:nvCxnSpPr>
        <p:spPr>
          <a:xfrm>
            <a:off x="5985262" y="1103124"/>
            <a:ext cx="0" cy="301752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D58BED99-EBFD-498E-BF07-8C3CD96BB556}"/>
              </a:ext>
            </a:extLst>
          </p:cNvPr>
          <p:cNvCxnSpPr>
            <a:cxnSpLocks/>
          </p:cNvCxnSpPr>
          <p:nvPr/>
        </p:nvCxnSpPr>
        <p:spPr>
          <a:xfrm>
            <a:off x="6116105" y="1101555"/>
            <a:ext cx="0" cy="3017520"/>
          </a:xfrm>
          <a:prstGeom prst="line">
            <a:avLst/>
          </a:prstGeom>
          <a:ln>
            <a:solidFill>
              <a:srgbClr val="00B05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D4ED86B4-EA5C-4CF6-91CE-8F883A1B632C}"/>
              </a:ext>
            </a:extLst>
          </p:cNvPr>
          <p:cNvCxnSpPr>
            <a:cxnSpLocks/>
          </p:cNvCxnSpPr>
          <p:nvPr/>
        </p:nvCxnSpPr>
        <p:spPr>
          <a:xfrm>
            <a:off x="7601691" y="1101555"/>
            <a:ext cx="0" cy="301752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5041933A-A734-459F-893A-7CA08ED3EDB4}"/>
              </a:ext>
            </a:extLst>
          </p:cNvPr>
          <p:cNvCxnSpPr>
            <a:cxnSpLocks/>
          </p:cNvCxnSpPr>
          <p:nvPr/>
        </p:nvCxnSpPr>
        <p:spPr>
          <a:xfrm>
            <a:off x="7812031" y="1101555"/>
            <a:ext cx="0" cy="3017520"/>
          </a:xfrm>
          <a:prstGeom prst="line">
            <a:avLst/>
          </a:prstGeom>
          <a:ln>
            <a:solidFill>
              <a:srgbClr val="00B05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95E36BE-54A0-464B-A96F-51E422833ACA}"/>
              </a:ext>
            </a:extLst>
          </p:cNvPr>
          <p:cNvCxnSpPr>
            <a:cxnSpLocks/>
          </p:cNvCxnSpPr>
          <p:nvPr/>
        </p:nvCxnSpPr>
        <p:spPr>
          <a:xfrm>
            <a:off x="8650335" y="1105028"/>
            <a:ext cx="0" cy="301752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67B0AA67-A9CC-497E-B825-132DC1687C96}"/>
              </a:ext>
            </a:extLst>
          </p:cNvPr>
          <p:cNvCxnSpPr>
            <a:cxnSpLocks/>
          </p:cNvCxnSpPr>
          <p:nvPr/>
        </p:nvCxnSpPr>
        <p:spPr>
          <a:xfrm>
            <a:off x="8930362" y="1113737"/>
            <a:ext cx="0" cy="3017520"/>
          </a:xfrm>
          <a:prstGeom prst="line">
            <a:avLst/>
          </a:prstGeom>
          <a:ln>
            <a:solidFill>
              <a:srgbClr val="00B050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9428CD2F-7C70-4EF1-B969-4FF777713493}"/>
              </a:ext>
            </a:extLst>
          </p:cNvPr>
          <p:cNvSpPr txBox="1"/>
          <p:nvPr/>
        </p:nvSpPr>
        <p:spPr>
          <a:xfrm>
            <a:off x="5169297" y="844485"/>
            <a:ext cx="548640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50" dirty="0" err="1"/>
              <a:t>DTInB</a:t>
            </a:r>
            <a:endParaRPr lang="en-US" sz="105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C53695B-051F-4405-8210-3DFA0F672DEB}"/>
              </a:ext>
            </a:extLst>
          </p:cNvPr>
          <p:cNvSpPr txBox="1"/>
          <p:nvPr/>
        </p:nvSpPr>
        <p:spPr>
          <a:xfrm>
            <a:off x="5843386" y="864668"/>
            <a:ext cx="548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DT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6FAB7D2-C77C-4B4B-A030-04D4593D8906}"/>
              </a:ext>
            </a:extLst>
          </p:cNvPr>
          <p:cNvSpPr txBox="1"/>
          <p:nvPr/>
        </p:nvSpPr>
        <p:spPr>
          <a:xfrm>
            <a:off x="7476063" y="861721"/>
            <a:ext cx="548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DTM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D3E35E8-89BC-426D-89A8-C0549DEF2E74}"/>
              </a:ext>
            </a:extLst>
          </p:cNvPr>
          <p:cNvSpPr txBox="1"/>
          <p:nvPr/>
        </p:nvSpPr>
        <p:spPr>
          <a:xfrm>
            <a:off x="8499429" y="848292"/>
            <a:ext cx="605661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50" dirty="0"/>
              <a:t>Harvest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B62CD85F-4A50-4527-877F-8AAA145BA51B}"/>
              </a:ext>
            </a:extLst>
          </p:cNvPr>
          <p:cNvCxnSpPr>
            <a:cxnSpLocks/>
          </p:cNvCxnSpPr>
          <p:nvPr/>
        </p:nvCxnSpPr>
        <p:spPr>
          <a:xfrm>
            <a:off x="2760181" y="787755"/>
            <a:ext cx="1463040" cy="6235"/>
          </a:xfrm>
          <a:prstGeom prst="line">
            <a:avLst/>
          </a:prstGeom>
          <a:ln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0F860F25-A3A2-486B-B15B-37D155561FC4}"/>
              </a:ext>
            </a:extLst>
          </p:cNvPr>
          <p:cNvSpPr txBox="1"/>
          <p:nvPr/>
        </p:nvSpPr>
        <p:spPr>
          <a:xfrm>
            <a:off x="4188442" y="665659"/>
            <a:ext cx="548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VGP 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AECBC359-F575-4230-948D-EB574CD31E56}"/>
              </a:ext>
            </a:extLst>
          </p:cNvPr>
          <p:cNvCxnSpPr>
            <a:cxnSpLocks/>
          </p:cNvCxnSpPr>
          <p:nvPr/>
        </p:nvCxnSpPr>
        <p:spPr>
          <a:xfrm>
            <a:off x="4585893" y="802699"/>
            <a:ext cx="1463040" cy="0"/>
          </a:xfrm>
          <a:prstGeom prst="line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9833F031-7932-4D93-B9D7-3146914EF8DD}"/>
              </a:ext>
            </a:extLst>
          </p:cNvPr>
          <p:cNvCxnSpPr>
            <a:cxnSpLocks/>
          </p:cNvCxnSpPr>
          <p:nvPr/>
        </p:nvCxnSpPr>
        <p:spPr>
          <a:xfrm>
            <a:off x="6066038" y="802972"/>
            <a:ext cx="640080" cy="0"/>
          </a:xfrm>
          <a:prstGeom prst="line">
            <a:avLst/>
          </a:prstGeom>
          <a:ln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EF5AD067-5449-4D6A-B25C-C5AE8D88842A}"/>
              </a:ext>
            </a:extLst>
          </p:cNvPr>
          <p:cNvSpPr txBox="1"/>
          <p:nvPr/>
        </p:nvSpPr>
        <p:spPr>
          <a:xfrm>
            <a:off x="6696639" y="679137"/>
            <a:ext cx="548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GFD 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A3B7F476-00BD-4353-8967-9026D16E86DF}"/>
              </a:ext>
            </a:extLst>
          </p:cNvPr>
          <p:cNvCxnSpPr/>
          <p:nvPr/>
        </p:nvCxnSpPr>
        <p:spPr>
          <a:xfrm>
            <a:off x="7082481" y="802699"/>
            <a:ext cx="640080" cy="0"/>
          </a:xfrm>
          <a:prstGeom prst="line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Rectangle 47">
            <a:extLst>
              <a:ext uri="{FF2B5EF4-FFF2-40B4-BE49-F238E27FC236}">
                <a16:creationId xmlns:a16="http://schemas.microsoft.com/office/drawing/2014/main" id="{AC689BA6-827B-4134-933F-21D294257A6F}"/>
              </a:ext>
            </a:extLst>
          </p:cNvPr>
          <p:cNvSpPr/>
          <p:nvPr/>
        </p:nvSpPr>
        <p:spPr>
          <a:xfrm>
            <a:off x="1909333" y="570271"/>
            <a:ext cx="7686539" cy="457310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863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EISIGACKER, Susanne (CIMMYT)</dc:creator>
  <cp:lastModifiedBy>DREISIGACKER, Susanne (CIMMYT)</cp:lastModifiedBy>
  <cp:revision>1</cp:revision>
  <dcterms:created xsi:type="dcterms:W3CDTF">2021-07-31T04:22:32Z</dcterms:created>
  <dcterms:modified xsi:type="dcterms:W3CDTF">2021-07-31T04:22:53Z</dcterms:modified>
</cp:coreProperties>
</file>